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532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71" userDrawn="1">
          <p15:clr>
            <a:srgbClr val="A4A3A4"/>
          </p15:clr>
        </p15:guide>
        <p15:guide id="2" pos="1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5493"/>
    <a:srgbClr val="2AFF9D"/>
    <a:srgbClr val="9DC3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59"/>
    <p:restoredTop sz="96081" autoAdjust="0"/>
  </p:normalViewPr>
  <p:slideViewPr>
    <p:cSldViewPr snapToGrid="0" snapToObjects="1">
      <p:cViewPr>
        <p:scale>
          <a:sx n="80" d="100"/>
          <a:sy n="80" d="100"/>
        </p:scale>
        <p:origin x="2624" y="152"/>
      </p:cViewPr>
      <p:guideLst>
        <p:guide orient="horz" pos="1971"/>
        <p:guide pos="19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lorechig/Documents/1_Wesleyan_University/HOLMES%20LAB/RESULTS/MEIOSIS/CYTOLOGY%20STRAINS/Cytology_Nuclei_Scoring_052119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2859618813471"/>
          <c:y val="3.9979604275000698E-2"/>
          <c:w val="0.61644835930318842"/>
          <c:h val="0.6041896909471192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031421-1old'!$J$437:$J$438</c:f>
              <c:strCache>
                <c:ptCount val="2"/>
                <c:pt idx="0">
                  <c:v>Diffuse</c:v>
                </c:pt>
              </c:strCache>
            </c:strRef>
          </c:tx>
          <c:spPr>
            <a:solidFill>
              <a:srgbClr val="9DC3E6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031421-1old'!$I$439:$I$447</c:f>
              <c:strCache>
                <c:ptCount val="8"/>
                <c:pt idx="0">
                  <c:v>wild type_Rec8</c:v>
                </c:pt>
                <c:pt idx="1">
                  <c:v>wild type_Red1</c:v>
                </c:pt>
                <c:pt idx="3">
                  <c:v>hho1∆_Rec8</c:v>
                </c:pt>
                <c:pt idx="4">
                  <c:v>hho1∆_Red1</c:v>
                </c:pt>
                <c:pt idx="6">
                  <c:v>htz1∆_Rec8</c:v>
                </c:pt>
                <c:pt idx="7">
                  <c:v>htz1∆_Red1</c:v>
                </c:pt>
              </c:strCache>
            </c:strRef>
          </c:cat>
          <c:val>
            <c:numRef>
              <c:f>'031421-1old'!$J$439:$J$447</c:f>
              <c:numCache>
                <c:formatCode>General</c:formatCode>
                <c:ptCount val="9"/>
                <c:pt idx="0" formatCode="0">
                  <c:v>5.1546391752577314</c:v>
                </c:pt>
                <c:pt idx="1">
                  <c:v>0</c:v>
                </c:pt>
                <c:pt idx="3" formatCode="0">
                  <c:v>9.2783505154639201</c:v>
                </c:pt>
                <c:pt idx="4">
                  <c:v>10.63829787234042</c:v>
                </c:pt>
                <c:pt idx="6" formatCode="0">
                  <c:v>41.53846153846154</c:v>
                </c:pt>
                <c:pt idx="7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BF-D340-AC21-6C9EB9EAE784}"/>
            </c:ext>
          </c:extLst>
        </c:ser>
        <c:ser>
          <c:idx val="1"/>
          <c:order val="1"/>
          <c:tx>
            <c:strRef>
              <c:f>'031421-1old'!$K$437:$K$438</c:f>
              <c:strCache>
                <c:ptCount val="2"/>
                <c:pt idx="0">
                  <c:v>Dotty linear</c:v>
                </c:pt>
              </c:strCache>
            </c:strRef>
          </c:tx>
          <c:spPr>
            <a:solidFill>
              <a:srgbClr val="2AFF9D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031421-1old'!$I$439:$I$447</c:f>
              <c:strCache>
                <c:ptCount val="8"/>
                <c:pt idx="0">
                  <c:v>wild type_Rec8</c:v>
                </c:pt>
                <c:pt idx="1">
                  <c:v>wild type_Red1</c:v>
                </c:pt>
                <c:pt idx="3">
                  <c:v>hho1∆_Rec8</c:v>
                </c:pt>
                <c:pt idx="4">
                  <c:v>hho1∆_Red1</c:v>
                </c:pt>
                <c:pt idx="6">
                  <c:v>htz1∆_Rec8</c:v>
                </c:pt>
                <c:pt idx="7">
                  <c:v>htz1∆_Red1</c:v>
                </c:pt>
              </c:strCache>
            </c:strRef>
          </c:cat>
          <c:val>
            <c:numRef>
              <c:f>'031421-1old'!$K$439:$K$447</c:f>
              <c:numCache>
                <c:formatCode>General</c:formatCode>
                <c:ptCount val="9"/>
                <c:pt idx="0" formatCode="0">
                  <c:v>82.474226804123703</c:v>
                </c:pt>
                <c:pt idx="1">
                  <c:v>89.795918367346943</c:v>
                </c:pt>
                <c:pt idx="3" formatCode="0">
                  <c:v>82.474226804123703</c:v>
                </c:pt>
                <c:pt idx="4">
                  <c:v>82.978723404255334</c:v>
                </c:pt>
                <c:pt idx="6" formatCode="0">
                  <c:v>32.307692307692292</c:v>
                </c:pt>
                <c:pt idx="7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BF-D340-AC21-6C9EB9EAE784}"/>
            </c:ext>
          </c:extLst>
        </c:ser>
        <c:ser>
          <c:idx val="2"/>
          <c:order val="2"/>
          <c:tx>
            <c:strRef>
              <c:f>'031421-1old'!$L$437:$L$438</c:f>
              <c:strCache>
                <c:ptCount val="2"/>
                <c:pt idx="0">
                  <c:v>Dotty</c:v>
                </c:pt>
              </c:strCache>
            </c:strRef>
          </c:tx>
          <c:spPr>
            <a:solidFill>
              <a:srgbClr val="005493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031421-1old'!$I$439:$I$447</c:f>
              <c:strCache>
                <c:ptCount val="8"/>
                <c:pt idx="0">
                  <c:v>wild type_Rec8</c:v>
                </c:pt>
                <c:pt idx="1">
                  <c:v>wild type_Red1</c:v>
                </c:pt>
                <c:pt idx="3">
                  <c:v>hho1∆_Rec8</c:v>
                </c:pt>
                <c:pt idx="4">
                  <c:v>hho1∆_Red1</c:v>
                </c:pt>
                <c:pt idx="6">
                  <c:v>htz1∆_Rec8</c:v>
                </c:pt>
                <c:pt idx="7">
                  <c:v>htz1∆_Red1</c:v>
                </c:pt>
              </c:strCache>
            </c:strRef>
          </c:cat>
          <c:val>
            <c:numRef>
              <c:f>'031421-1old'!$L$439:$L$447</c:f>
              <c:numCache>
                <c:formatCode>General</c:formatCode>
                <c:ptCount val="9"/>
                <c:pt idx="0" formatCode="0">
                  <c:v>12.3711340206186</c:v>
                </c:pt>
                <c:pt idx="1">
                  <c:v>10.204081632653059</c:v>
                </c:pt>
                <c:pt idx="3" formatCode="0">
                  <c:v>8.2474226804123667</c:v>
                </c:pt>
                <c:pt idx="4">
                  <c:v>6.3829787234042552</c:v>
                </c:pt>
                <c:pt idx="6" formatCode="0">
                  <c:v>26.15384615384616</c:v>
                </c:pt>
                <c:pt idx="7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BF-D340-AC21-6C9EB9EAE7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overlap val="100"/>
        <c:axId val="-2135119560"/>
        <c:axId val="-2135115960"/>
      </c:barChart>
      <c:catAx>
        <c:axId val="-21351195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35115960"/>
        <c:crosses val="autoZero"/>
        <c:auto val="1"/>
        <c:lblAlgn val="ctr"/>
        <c:lblOffset val="100"/>
        <c:tickMarkSkip val="3"/>
        <c:noMultiLvlLbl val="0"/>
      </c:catAx>
      <c:valAx>
        <c:axId val="-2135115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Percentage of nucle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3511956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6134994842267356"/>
          <c:y val="3.6650323875430456E-2"/>
          <c:w val="0.238650068444268"/>
          <c:h val="0.262758678399108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69</cdr:x>
      <cdr:y>0.66566</cdr:y>
    </cdr:from>
    <cdr:to>
      <cdr:x>0.74456</cdr:x>
      <cdr:y>0.7360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40DA35A9-8B49-5843-84F7-D995221226A9}"/>
            </a:ext>
          </a:extLst>
        </cdr:cNvPr>
        <cdr:cNvSpPr txBox="1"/>
      </cdr:nvSpPr>
      <cdr:spPr>
        <a:xfrm xmlns:a="http://schemas.openxmlformats.org/drawingml/2006/main">
          <a:off x="1100496" y="3603638"/>
          <a:ext cx="4477468" cy="3809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dirty="0">
              <a:latin typeface="Arial" panose="020B0604020202020204" pitchFamily="34" charset="0"/>
              <a:cs typeface="Arial" panose="020B0604020202020204" pitchFamily="34" charset="0"/>
            </a:rPr>
            <a:t>Rec8 Red1    Rec8 Red1    Rec8 Red1     </a:t>
          </a:r>
        </a:p>
      </cdr:txBody>
    </cdr:sp>
  </cdr:relSizeAnchor>
  <cdr:relSizeAnchor xmlns:cdr="http://schemas.openxmlformats.org/drawingml/2006/chartDrawing">
    <cdr:from>
      <cdr:x>0.15342</cdr:x>
      <cdr:y>0.73666</cdr:y>
    </cdr:from>
    <cdr:to>
      <cdr:x>0.78293</cdr:x>
      <cdr:y>0.8161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7A7BB5FC-1C25-DE41-AA1C-4F7E0C8332BF}"/>
            </a:ext>
          </a:extLst>
        </cdr:cNvPr>
        <cdr:cNvSpPr txBox="1"/>
      </cdr:nvSpPr>
      <cdr:spPr>
        <a:xfrm xmlns:a="http://schemas.openxmlformats.org/drawingml/2006/main">
          <a:off x="1149366" y="3988015"/>
          <a:ext cx="4716049" cy="4300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i="1" dirty="0">
              <a:latin typeface="Arial" panose="020B0604020202020204" pitchFamily="34" charset="0"/>
              <a:cs typeface="Arial" panose="020B0604020202020204" pitchFamily="34" charset="0"/>
            </a:rPr>
            <a:t>wild-type           hho1△            htz1△</a:t>
          </a:r>
        </a:p>
      </cdr:txBody>
    </cdr:sp>
  </cdr:relSizeAnchor>
  <cdr:relSizeAnchor xmlns:cdr="http://schemas.openxmlformats.org/drawingml/2006/chartDrawing">
    <cdr:from>
      <cdr:x>0.09422</cdr:x>
      <cdr:y>0.81722</cdr:y>
    </cdr:from>
    <cdr:to>
      <cdr:x>0.77663</cdr:x>
      <cdr:y>0.89212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04261481-90AA-9440-973E-EB0952F04BA8}"/>
            </a:ext>
          </a:extLst>
        </cdr:cNvPr>
        <cdr:cNvSpPr txBox="1"/>
      </cdr:nvSpPr>
      <cdr:spPr>
        <a:xfrm xmlns:a="http://schemas.openxmlformats.org/drawingml/2006/main">
          <a:off x="705853" y="4424183"/>
          <a:ext cx="5112413" cy="4054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dirty="0">
              <a:latin typeface="Arial" panose="020B0604020202020204" pitchFamily="34" charset="0"/>
              <a:cs typeface="Arial" panose="020B0604020202020204" pitchFamily="34" charset="0"/>
            </a:rPr>
            <a:t>N =   97   49           97   47           65   30</a:t>
          </a:r>
        </a:p>
      </cdr:txBody>
    </cdr:sp>
  </cdr:relSizeAnchor>
  <cdr:relSizeAnchor xmlns:cdr="http://schemas.openxmlformats.org/drawingml/2006/chartDrawing">
    <cdr:from>
      <cdr:x>0.2093</cdr:x>
      <cdr:y>0.89036</cdr:y>
    </cdr:from>
    <cdr:to>
      <cdr:x>0.79443</cdr:x>
      <cdr:y>0.97333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FEFA67BA-C274-0848-8A77-0B83D98B1948}"/>
            </a:ext>
          </a:extLst>
        </cdr:cNvPr>
        <cdr:cNvSpPr txBox="1"/>
      </cdr:nvSpPr>
      <cdr:spPr>
        <a:xfrm xmlns:a="http://schemas.openxmlformats.org/drawingml/2006/main">
          <a:off x="1567971" y="4820113"/>
          <a:ext cx="4383651" cy="4491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dirty="0">
              <a:latin typeface="Arial" panose="020B0604020202020204" pitchFamily="34" charset="0"/>
              <a:cs typeface="Arial" panose="020B0604020202020204" pitchFamily="34" charset="0"/>
            </a:rPr>
            <a:t>24 hours post meiotic induction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E9492E-118D-314A-A4DC-0DC0A20DEF42}" type="datetimeFigureOut">
              <a:rPr lang="en-US" smtClean="0"/>
              <a:t>5/1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FBA4E-D211-A743-AB8E-8EDA679F2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0482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/>
              <a:t>– linked with Figure 5B </a:t>
            </a:r>
            <a:endParaRPr lang="en-US" dirty="0">
              <a:solidFill>
                <a:srgbClr val="FF0000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FBA4E-D211-A743-AB8E-8EDA679F285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002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25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357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591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538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453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68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440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225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522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389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452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87EFC3-26E8-5E48-9409-CEBE992ED281}" type="datetimeFigureOut">
              <a:rPr lang="en-US" smtClean="0"/>
              <a:t>5/1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1556F-0CD1-414E-8E22-0ABD27C73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885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EF0E325B-1089-9E48-92F0-54455747F3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3243002"/>
              </p:ext>
            </p:extLst>
          </p:nvPr>
        </p:nvGraphicFramePr>
        <p:xfrm>
          <a:off x="160421" y="714413"/>
          <a:ext cx="7491664" cy="54136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8625B3B2-D878-5940-8F92-0A9D51B78AA0}"/>
              </a:ext>
            </a:extLst>
          </p:cNvPr>
          <p:cNvSpPr/>
          <p:nvPr/>
        </p:nvSpPr>
        <p:spPr>
          <a:xfrm>
            <a:off x="160421" y="48126"/>
            <a:ext cx="134338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524143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916</TotalTime>
  <Words>35</Words>
  <Application>Microsoft Macintosh PowerPoint</Application>
  <PresentationFormat>Custom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iosis paper</dc:title>
  <dc:creator>Chigweshe, Lorencia</dc:creator>
  <cp:lastModifiedBy>Lorencia Chigweshe</cp:lastModifiedBy>
  <cp:revision>475</cp:revision>
  <cp:lastPrinted>2020-07-14T22:54:43Z</cp:lastPrinted>
  <dcterms:created xsi:type="dcterms:W3CDTF">2020-06-05T14:36:22Z</dcterms:created>
  <dcterms:modified xsi:type="dcterms:W3CDTF">2022-05-11T14:25:18Z</dcterms:modified>
</cp:coreProperties>
</file>